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3208000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69" d="100"/>
          <a:sy n="69" d="100"/>
        </p:scale>
        <p:origin x="931" y="-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2930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005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646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4966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6852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8161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191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820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321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6216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554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1C6B6C-136C-44E7-BC11-B9B65564B422}" type="datetimeFigureOut">
              <a:rPr lang="zh-CN" altLang="en-US" smtClean="0"/>
              <a:t>2025/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EE95CB-810F-4D78-8735-CDC4FA53F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4012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FD41B3B-70E3-3AF2-DF35-7E26F84AF6E7}"/>
              </a:ext>
            </a:extLst>
          </p:cNvPr>
          <p:cNvSpPr txBox="1"/>
          <p:nvPr/>
        </p:nvSpPr>
        <p:spPr>
          <a:xfrm>
            <a:off x="232789" y="300853"/>
            <a:ext cx="49055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unedited gel/blot for Figure 5 B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71545D1-A848-9D86-FFAD-6C51B27766C7}"/>
              </a:ext>
            </a:extLst>
          </p:cNvPr>
          <p:cNvSpPr txBox="1"/>
          <p:nvPr/>
        </p:nvSpPr>
        <p:spPr>
          <a:xfrm>
            <a:off x="3072513" y="6481744"/>
            <a:ext cx="1283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5FED5C7-2965-561B-B8EE-0667DA462B26}"/>
              </a:ext>
            </a:extLst>
          </p:cNvPr>
          <p:cNvSpPr txBox="1"/>
          <p:nvPr/>
        </p:nvSpPr>
        <p:spPr>
          <a:xfrm>
            <a:off x="3140364" y="3282846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R-2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5F66D9C-3574-9212-2E84-E846F1A326C1}"/>
              </a:ext>
            </a:extLst>
          </p:cNvPr>
          <p:cNvSpPr txBox="1"/>
          <p:nvPr/>
        </p:nvSpPr>
        <p:spPr>
          <a:xfrm>
            <a:off x="3140364" y="4288130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R-2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FA3CB20-5C9B-3264-ED9E-9EE7B08E96B9}"/>
              </a:ext>
            </a:extLst>
          </p:cNvPr>
          <p:cNvSpPr txBox="1"/>
          <p:nvPr/>
        </p:nvSpPr>
        <p:spPr>
          <a:xfrm>
            <a:off x="3140364" y="2250047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R-2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996C0A0-72F5-06D6-F3D5-6EF86ACD3198}"/>
              </a:ext>
            </a:extLst>
          </p:cNvPr>
          <p:cNvSpPr txBox="1"/>
          <p:nvPr/>
        </p:nvSpPr>
        <p:spPr>
          <a:xfrm>
            <a:off x="3140364" y="5400485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R-2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EDEB7BD-6184-6928-8739-969A1586A4CB}"/>
              </a:ext>
            </a:extLst>
          </p:cNvPr>
          <p:cNvSpPr txBox="1"/>
          <p:nvPr/>
        </p:nvSpPr>
        <p:spPr>
          <a:xfrm>
            <a:off x="8104337" y="2342380"/>
            <a:ext cx="10304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C3DCD478-03DB-2386-8421-4EACC81F8848}"/>
              </a:ext>
            </a:extLst>
          </p:cNvPr>
          <p:cNvSpPr txBox="1"/>
          <p:nvPr/>
        </p:nvSpPr>
        <p:spPr>
          <a:xfrm>
            <a:off x="8104337" y="3281067"/>
            <a:ext cx="10304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871AED5-A6E5-4E99-7AAF-BC50A7422099}"/>
              </a:ext>
            </a:extLst>
          </p:cNvPr>
          <p:cNvSpPr txBox="1"/>
          <p:nvPr/>
        </p:nvSpPr>
        <p:spPr>
          <a:xfrm>
            <a:off x="8104337" y="4382670"/>
            <a:ext cx="10304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E445C6DC-C001-4D0F-BC50-6B54FAC3069F}"/>
              </a:ext>
            </a:extLst>
          </p:cNvPr>
          <p:cNvSpPr txBox="1"/>
          <p:nvPr/>
        </p:nvSpPr>
        <p:spPr>
          <a:xfrm>
            <a:off x="8104337" y="5446651"/>
            <a:ext cx="10304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C5FA992-DFF5-C6D8-9780-C9010712B7F5}"/>
              </a:ext>
            </a:extLst>
          </p:cNvPr>
          <p:cNvSpPr txBox="1"/>
          <p:nvPr/>
        </p:nvSpPr>
        <p:spPr>
          <a:xfrm>
            <a:off x="8104338" y="6540359"/>
            <a:ext cx="10304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6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8DAE5387-4F2E-149D-A45E-FD18388A12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9161" y="2165946"/>
            <a:ext cx="3311748" cy="578633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889F5213-310F-FA66-CA95-B0810716E2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39161" y="3114862"/>
            <a:ext cx="3311748" cy="578633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DE470F48-CA03-D346-9C0C-091BCE06B8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9161" y="4140715"/>
            <a:ext cx="3311748" cy="652501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F2EF1592-5BF2-F85C-63CF-408433BA4BB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39161" y="5240436"/>
            <a:ext cx="3311748" cy="566321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2F2980B5-F327-D5D4-C9F9-381A5F63DA9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39161" y="6253977"/>
            <a:ext cx="3311748" cy="566321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A762477F-B485-3A6D-33AE-CA559513B464}"/>
              </a:ext>
            </a:extLst>
          </p:cNvPr>
          <p:cNvSpPr txBox="1"/>
          <p:nvPr/>
        </p:nvSpPr>
        <p:spPr>
          <a:xfrm rot="18502111">
            <a:off x="4530752" y="1383194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-1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39351387-98D0-BA47-F3BD-EAE8426728D5}"/>
              </a:ext>
            </a:extLst>
          </p:cNvPr>
          <p:cNvSpPr txBox="1"/>
          <p:nvPr/>
        </p:nvSpPr>
        <p:spPr>
          <a:xfrm rot="18502111">
            <a:off x="5077551" y="1383194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-2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157F9922-6614-46FB-FBCD-7D8891C1E673}"/>
              </a:ext>
            </a:extLst>
          </p:cNvPr>
          <p:cNvSpPr txBox="1"/>
          <p:nvPr/>
        </p:nvSpPr>
        <p:spPr>
          <a:xfrm rot="18502111">
            <a:off x="5625242" y="1383194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-3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5E326A6B-569A-0BC6-DF03-387CD7CE8039}"/>
              </a:ext>
            </a:extLst>
          </p:cNvPr>
          <p:cNvSpPr txBox="1"/>
          <p:nvPr/>
        </p:nvSpPr>
        <p:spPr>
          <a:xfrm rot="18502111">
            <a:off x="6237605" y="1383194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-1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72D1DA4C-738F-7604-D8E1-65346C6F3913}"/>
              </a:ext>
            </a:extLst>
          </p:cNvPr>
          <p:cNvSpPr txBox="1"/>
          <p:nvPr/>
        </p:nvSpPr>
        <p:spPr>
          <a:xfrm rot="18502111">
            <a:off x="6733426" y="1383194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-2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089281CA-7489-BF75-341C-4D5BA4CEEEC1}"/>
              </a:ext>
            </a:extLst>
          </p:cNvPr>
          <p:cNvSpPr txBox="1"/>
          <p:nvPr/>
        </p:nvSpPr>
        <p:spPr>
          <a:xfrm rot="18502111">
            <a:off x="7266534" y="1383194"/>
            <a:ext cx="1215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-3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6288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4</TotalTime>
  <Words>30</Words>
  <Application>Microsoft Office PowerPoint</Application>
  <PresentationFormat>自定义</PresentationFormat>
  <Paragraphs>1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井来 武</dc:creator>
  <cp:lastModifiedBy>E</cp:lastModifiedBy>
  <cp:revision>4</cp:revision>
  <dcterms:created xsi:type="dcterms:W3CDTF">2025-02-01T12:05:44Z</dcterms:created>
  <dcterms:modified xsi:type="dcterms:W3CDTF">2025-02-02T14:33:57Z</dcterms:modified>
</cp:coreProperties>
</file>